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1F436-4D41-4E97-9B4E-4AE8CE670C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E9F58-CF08-4C47-B549-BCA4CA4E95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3942A-FFC7-4970-AE10-12F3A85185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32AC6-8B50-40D4-B5C3-63DD4FFC9C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DA03D-9949-4FBD-B0D4-783E05568A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B4222-E8C5-43CA-AC45-1828CD1FB3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20E56-6198-4C24-B37B-C7FF070CB4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4ED41-097F-44DA-AD22-CB3D8F70F7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D44C4-4CC9-40DD-92E8-9D7DCF0257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9B6B7-A425-4C8F-90C9-D2F5B14B94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BB3E2-A7FD-43E4-AC71-7A6B6960E8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0E8BC-A051-4BF9-9A15-93383668A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A1D74C-6D6F-420A-BEB7-C15D8E7C49AA}" type="slidenum">
              <a:rPr b="0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8000" y="0"/>
            <a:ext cx="2998800" cy="2797560"/>
            <a:chOff x="108000" y="0"/>
            <a:chExt cx="2998800" cy="2797560"/>
          </a:xfrm>
        </p:grpSpPr>
        <p:graphicFrame>
          <p:nvGraphicFramePr>
            <p:cNvPr id="42" name=""/>
            <p:cNvGraphicFramePr/>
            <p:nvPr/>
          </p:nvGraphicFramePr>
          <p:xfrm>
            <a:off x="249480" y="319320"/>
            <a:ext cx="2857320" cy="20761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49480" y="319320"/>
                      <a:ext cx="2857320" cy="2076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 rot="16200000">
              <a:off x="-596880" y="1115640"/>
              <a:ext cx="1686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l-PL" sz="1200" spc="-1" strike="noStrike">
                  <a:solidFill>
                    <a:srgbClr val="000000"/>
                  </a:solidFill>
                  <a:latin typeface="Arial"/>
                </a:rPr>
                <a:t>Relative luc. activity</a:t>
              </a:r>
              <a:r>
                <a:rPr b="0" lang="pl-PL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52680" y="2243160"/>
              <a:ext cx="257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l-PL" sz="1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flipH="1">
              <a:off x="969480" y="2305080"/>
              <a:ext cx="865080" cy="142920"/>
            </a:xfrm>
            <a:prstGeom prst="rtTriangl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20" bIns="-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H="1">
              <a:off x="1977480" y="2305080"/>
              <a:ext cx="865080" cy="142920"/>
            </a:xfrm>
            <a:prstGeom prst="rtTriangl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20" bIns="-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041840" y="2521080"/>
              <a:ext cx="186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l-PL" sz="1200" spc="-1" strike="noStrike">
                  <a:solidFill>
                    <a:srgbClr val="000000"/>
                  </a:solidFill>
                  <a:latin typeface="Arial"/>
                </a:rPr>
                <a:t>Elk-En             Elk-VP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"/>
            <p:cNvGrpSpPr/>
            <p:nvPr/>
          </p:nvGrpSpPr>
          <p:grpSpPr>
            <a:xfrm>
              <a:off x="825480" y="0"/>
              <a:ext cx="1800000" cy="420840"/>
              <a:chOff x="825480" y="0"/>
              <a:chExt cx="1800000" cy="420840"/>
            </a:xfrm>
          </p:grpSpPr>
          <p:sp>
            <p:nvSpPr>
              <p:cNvPr id="50" name=""/>
              <p:cNvSpPr/>
              <p:nvPr/>
            </p:nvSpPr>
            <p:spPr>
              <a:xfrm>
                <a:off x="825480" y="215640"/>
                <a:ext cx="1800000" cy="142920"/>
              </a:xfrm>
              <a:prstGeom prst="rect">
                <a:avLst/>
              </a:prstGeom>
              <a:gradFill rotWithShape="0">
                <a:gsLst>
                  <a:gs pos="0">
                    <a:srgbClr val="585858"/>
                  </a:gs>
                  <a:gs pos="50000">
                    <a:srgbClr val="c0c0c0"/>
                  </a:gs>
                  <a:gs pos="100000">
                    <a:srgbClr val="585858"/>
                  </a:gs>
                </a:gsLst>
                <a:lin ang="540000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977840" y="215640"/>
                <a:ext cx="647640" cy="142920"/>
              </a:xfrm>
              <a:prstGeom prst="rect">
                <a:avLst/>
              </a:prstGeom>
              <a:gradFill rotWithShape="0">
                <a:gsLst>
                  <a:gs pos="0">
                    <a:srgbClr val="656565"/>
                  </a:gs>
                  <a:gs pos="50000">
                    <a:srgbClr val="dddddd"/>
                  </a:gs>
                  <a:gs pos="100000">
                    <a:srgbClr val="656565"/>
                  </a:gs>
                </a:gsLst>
                <a:lin ang="5400000"/>
              </a:gra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187640" y="174600"/>
                <a:ext cx="1296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l-PL" sz="1000" spc="-1" strike="noStrike">
                    <a:solidFill>
                      <a:srgbClr val="000000"/>
                    </a:solidFill>
                    <a:latin typeface="Arial"/>
                  </a:rPr>
                  <a:t>MCPIP              Lu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761840" y="0"/>
                <a:ext cx="360360" cy="215640"/>
              </a:xfrm>
              <a:custGeom>
                <a:avLst/>
                <a:gdLst>
                  <a:gd name="textAreaLeft" fmla="*/ 0 w 360360"/>
                  <a:gd name="textAreaRight" fmla="*/ 360720 w 360360"/>
                  <a:gd name="textAreaTop" fmla="*/ 0 h 215640"/>
                  <a:gd name="textAreaBottom" fmla="*/ 216000 h 215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21600"/>
                    </a:moveTo>
                    <a:lnTo>
                      <a:pt x="0" y="12160"/>
                    </a:lnTo>
                    <a:arcTo wR="12427" hR="9260" stAng="10800000" swAng="5400000"/>
                    <a:lnTo>
                      <a:pt x="15100" y="2900"/>
                    </a:lnTo>
                    <a:lnTo>
                      <a:pt x="15100" y="0"/>
                    </a:lnTo>
                    <a:lnTo>
                      <a:pt x="21600" y="6079"/>
                    </a:lnTo>
                    <a:lnTo>
                      <a:pt x="15100" y="12158"/>
                    </a:lnTo>
                    <a:lnTo>
                      <a:pt x="15100" y="9258"/>
                    </a:lnTo>
                    <a:lnTo>
                      <a:pt x="12427" y="9258"/>
                    </a:lnTo>
                    <a:arcTo wR="6069" hR="2902" stAng="16200000" swAng="-5400000"/>
                    <a:lnTo>
                      <a:pt x="6358" y="21600"/>
                    </a:lnTo>
                    <a:close/>
                  </a:path>
                </a:pathLst>
              </a:cu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4" name=""/>
          <p:cNvSpPr/>
          <p:nvPr/>
        </p:nvSpPr>
        <p:spPr>
          <a:xfrm>
            <a:off x="1965600" y="119232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91360" y="63180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00680" y="83520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437200" y="866880"/>
            <a:ext cx="27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24400" y="184320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473480" y="182088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11280" y="3545640"/>
            <a:ext cx="7416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3. Regulation of  2038 bp length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ZC3H12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promoter fragment by Elk-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epG2 cells were transiently transfected with the luciferase construct containing fragment of huma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ZC3H12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moter located between -1050 and +988 and increasing amounts of pElk-En (20, 50, 100, 200ng – lanes 2, 3, 4, 5) or Elk-VP16 (20, 50, 100, 200ng – lanes 6, 7, 8, 9). Lane 1 – control cells without Elk-En or Elk-VP16. Luciferase activity was measured 24 h after transfection. Statistical significance was determined using the Student’s test. *P&lt;0.05, **P&lt;0.00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2T12:06:12Z</dcterms:created>
  <dc:creator>x</dc:creator>
  <dc:description/>
  <dc:language>en-US</dc:language>
  <cp:lastModifiedBy>Kate Mosford</cp:lastModifiedBy>
  <dcterms:modified xsi:type="dcterms:W3CDTF">2010-01-21T16:00:33Z</dcterms:modified>
  <cp:revision>45</cp:revision>
  <dc:subject/>
  <dc:title>Slajd 1</dc:title>
</cp:coreProperties>
</file>